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7" autoAdjust="0"/>
    <p:restoredTop sz="94660"/>
  </p:normalViewPr>
  <p:slideViewPr>
    <p:cSldViewPr snapToGrid="0">
      <p:cViewPr varScale="1">
        <p:scale>
          <a:sx n="98" d="100"/>
          <a:sy n="98" d="100"/>
        </p:scale>
        <p:origin x="25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CBDBB-7C75-4BB9-97FC-609DD57AE135}" type="datetimeFigureOut">
              <a:rPr lang="en-US" smtClean="0"/>
              <a:t>3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1AE6B-42A1-419B-860B-2AAE48D45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07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CBDBB-7C75-4BB9-97FC-609DD57AE135}" type="datetimeFigureOut">
              <a:rPr lang="en-US" smtClean="0"/>
              <a:t>3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1AE6B-42A1-419B-860B-2AAE48D45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5378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CBDBB-7C75-4BB9-97FC-609DD57AE135}" type="datetimeFigureOut">
              <a:rPr lang="en-US" smtClean="0"/>
              <a:t>3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1AE6B-42A1-419B-860B-2AAE48D45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0785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CBDBB-7C75-4BB9-97FC-609DD57AE135}" type="datetimeFigureOut">
              <a:rPr lang="en-US" smtClean="0"/>
              <a:t>3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1AE6B-42A1-419B-860B-2AAE48D45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00422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CBDBB-7C75-4BB9-97FC-609DD57AE135}" type="datetimeFigureOut">
              <a:rPr lang="en-US" smtClean="0"/>
              <a:t>3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1AE6B-42A1-419B-860B-2AAE48D45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735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CBDBB-7C75-4BB9-97FC-609DD57AE135}" type="datetimeFigureOut">
              <a:rPr lang="en-US" smtClean="0"/>
              <a:t>3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1AE6B-42A1-419B-860B-2AAE48D45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3135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CBDBB-7C75-4BB9-97FC-609DD57AE135}" type="datetimeFigureOut">
              <a:rPr lang="en-US" smtClean="0"/>
              <a:t>3/1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1AE6B-42A1-419B-860B-2AAE48D45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770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CBDBB-7C75-4BB9-97FC-609DD57AE135}" type="datetimeFigureOut">
              <a:rPr lang="en-US" smtClean="0"/>
              <a:t>3/1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1AE6B-42A1-419B-860B-2AAE48D45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409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CBDBB-7C75-4BB9-97FC-609DD57AE135}" type="datetimeFigureOut">
              <a:rPr lang="en-US" smtClean="0"/>
              <a:t>3/1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1AE6B-42A1-419B-860B-2AAE48D45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873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CBDBB-7C75-4BB9-97FC-609DD57AE135}" type="datetimeFigureOut">
              <a:rPr lang="en-US" smtClean="0"/>
              <a:t>3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1AE6B-42A1-419B-860B-2AAE48D45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002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CBDBB-7C75-4BB9-97FC-609DD57AE135}" type="datetimeFigureOut">
              <a:rPr lang="en-US" smtClean="0"/>
              <a:t>3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1AE6B-42A1-419B-860B-2AAE48D45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34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9CBDBB-7C75-4BB9-97FC-609DD57AE135}" type="datetimeFigureOut">
              <a:rPr lang="en-US" smtClean="0"/>
              <a:t>3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C1AE6B-42A1-419B-860B-2AAE48D45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920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F7A1215-7019-A354-D859-EDB8975D1E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0050" y="802992"/>
            <a:ext cx="4048095" cy="586486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CCA70E9-4B57-B094-760E-BC0FABE10FF9}"/>
              </a:ext>
            </a:extLst>
          </p:cNvPr>
          <p:cNvSpPr txBox="1"/>
          <p:nvPr/>
        </p:nvSpPr>
        <p:spPr>
          <a:xfrm>
            <a:off x="946014" y="6737283"/>
            <a:ext cx="562988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.  Sibling Survival.  A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Survival curves comparing age of death for first and second born siblings with NPC1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urvival curves comparing age of death for male and female siblings with NPC1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1975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1" id="{D93C54C5-8862-4C28-84CB-1C70F751BD5C}" vid="{02092DB1-5FB2-44A5-9C08-FA827EA3E378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Figures  8.5 x 11</Template>
  <TotalTime>3</TotalTime>
  <Words>40</Words>
  <Application>Microsoft Office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rter, Forbes (NIH/NICHD) [E]</dc:creator>
  <cp:lastModifiedBy>Porter, Forbes (NIH/NICHD) [E]</cp:lastModifiedBy>
  <cp:revision>1</cp:revision>
  <dcterms:created xsi:type="dcterms:W3CDTF">2024-03-14T14:23:42Z</dcterms:created>
  <dcterms:modified xsi:type="dcterms:W3CDTF">2024-03-14T14:26:52Z</dcterms:modified>
</cp:coreProperties>
</file>